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8"/>
  </p:notesMasterIdLst>
  <p:handoutMasterIdLst>
    <p:handoutMasterId r:id="rId19"/>
  </p:handoutMasterIdLst>
  <p:sldIdLst>
    <p:sldId id="277" r:id="rId5"/>
    <p:sldId id="314" r:id="rId6"/>
    <p:sldId id="315" r:id="rId7"/>
    <p:sldId id="316" r:id="rId8"/>
    <p:sldId id="378" r:id="rId9"/>
    <p:sldId id="379" r:id="rId10"/>
    <p:sldId id="327" r:id="rId11"/>
    <p:sldId id="329" r:id="rId12"/>
    <p:sldId id="363" r:id="rId13"/>
    <p:sldId id="365" r:id="rId14"/>
    <p:sldId id="392" r:id="rId15"/>
    <p:sldId id="390" r:id="rId16"/>
    <p:sldId id="372" r:id="rId17"/>
  </p:sldIdLst>
  <p:sldSz cx="12192000" cy="12192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blogargon1@gmail.com" initials="p" lastIdx="1" clrIdx="0">
    <p:extLst>
      <p:ext uri="{19B8F6BF-5375-455C-9EA6-DF929625EA0E}">
        <p15:presenceInfo xmlns:p15="http://schemas.microsoft.com/office/powerpoint/2012/main" userId="ac67d1d8a74de6e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9A9A9"/>
    <a:srgbClr val="CD5555"/>
    <a:srgbClr val="000080"/>
    <a:srgbClr val="6E8B3D"/>
    <a:srgbClr val="FF0000"/>
    <a:srgbClr val="9119DB"/>
    <a:srgbClr val="C585ED"/>
    <a:srgbClr val="9F1DF0"/>
    <a:srgbClr val="0000FF"/>
    <a:srgbClr val="A02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20" autoAdjust="0"/>
    <p:restoredTop sz="87705" autoAdjust="0"/>
  </p:normalViewPr>
  <p:slideViewPr>
    <p:cSldViewPr snapToGrid="0">
      <p:cViewPr varScale="1">
        <p:scale>
          <a:sx n="65" d="100"/>
          <a:sy n="65" d="100"/>
        </p:scale>
        <p:origin x="2382" y="84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notesViewPr>
    <p:cSldViewPr snapToGrid="0">
      <p:cViewPr varScale="1">
        <p:scale>
          <a:sx n="87" d="100"/>
          <a:sy n="87" d="100"/>
        </p:scale>
        <p:origin x="2988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presProps" Target="pres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commentAuthors" Target="comment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ableStyles" Target="tableStyles.xml"/><Relationship Id="rId87" Type="http://schemas.microsoft.com/office/2016/11/relationships/changesInfo" Target="changesInfos/changesInfo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RCIA GONZALEZ, PABLO" userId="a2e58272-c434-4247-ba31-462042e35682" providerId="ADAL" clId="{2D89B2DF-EA0F-4EF0-90B4-45D2CD0F1972}"/>
    <pc:docChg chg="undo custSel addSld modSld">
      <pc:chgData name="GARCIA GONZALEZ, PABLO" userId="a2e58272-c434-4247-ba31-462042e35682" providerId="ADAL" clId="{2D89B2DF-EA0F-4EF0-90B4-45D2CD0F1972}" dt="2024-09-02T11:37:36.149" v="623" actId="20577"/>
      <pc:docMkLst>
        <pc:docMk/>
      </pc:docMkLst>
      <pc:sldChg chg="addSp delSp modSp new mod modNotesTx">
        <pc:chgData name="GARCIA GONZALEZ, PABLO" userId="a2e58272-c434-4247-ba31-462042e35682" providerId="ADAL" clId="{2D89B2DF-EA0F-4EF0-90B4-45D2CD0F1972}" dt="2024-09-02T11:37:36.149" v="623" actId="20577"/>
        <pc:sldMkLst>
          <pc:docMk/>
          <pc:sldMk cId="4249151160" sldId="292"/>
        </pc:sldMkLst>
        <pc:spChg chg="del">
          <ac:chgData name="GARCIA GONZALEZ, PABLO" userId="a2e58272-c434-4247-ba31-462042e35682" providerId="ADAL" clId="{2D89B2DF-EA0F-4EF0-90B4-45D2CD0F1972}" dt="2024-08-30T10:10:24.667" v="1" actId="478"/>
          <ac:spMkLst>
            <pc:docMk/>
            <pc:sldMk cId="4249151160" sldId="292"/>
            <ac:spMk id="2" creationId="{00819C80-D7E7-F368-A7B0-643A3E7DE112}"/>
          </ac:spMkLst>
        </pc:spChg>
        <pc:spChg chg="del">
          <ac:chgData name="GARCIA GONZALEZ, PABLO" userId="a2e58272-c434-4247-ba31-462042e35682" providerId="ADAL" clId="{2D89B2DF-EA0F-4EF0-90B4-45D2CD0F1972}" dt="2024-08-30T10:10:26.068" v="2" actId="478"/>
          <ac:spMkLst>
            <pc:docMk/>
            <pc:sldMk cId="4249151160" sldId="292"/>
            <ac:spMk id="3" creationId="{D5DDBAF4-7C40-7CA2-CAA0-CD1B8B3D7E05}"/>
          </ac:spMkLst>
        </pc:spChg>
        <pc:spChg chg="add mod">
          <ac:chgData name="GARCIA GONZALEZ, PABLO" userId="a2e58272-c434-4247-ba31-462042e35682" providerId="ADAL" clId="{2D89B2DF-EA0F-4EF0-90B4-45D2CD0F1972}" dt="2024-09-02T11:37:36.149" v="623" actId="20577"/>
          <ac:spMkLst>
            <pc:docMk/>
            <pc:sldMk cId="4249151160" sldId="292"/>
            <ac:spMk id="6" creationId="{C7AB300D-6A11-4F22-9377-EFFD6D8FC09E}"/>
          </ac:spMkLst>
        </pc:spChg>
        <pc:picChg chg="add mod">
          <ac:chgData name="GARCIA GONZALEZ, PABLO" userId="a2e58272-c434-4247-ba31-462042e35682" providerId="ADAL" clId="{2D89B2DF-EA0F-4EF0-90B4-45D2CD0F1972}" dt="2024-08-30T10:10:39.494" v="8" actId="1076"/>
          <ac:picMkLst>
            <pc:docMk/>
            <pc:sldMk cId="4249151160" sldId="292"/>
            <ac:picMk id="4" creationId="{72D83066-F596-36FC-434E-443B04AE0687}"/>
          </ac:picMkLst>
        </pc:picChg>
        <pc:picChg chg="add mod">
          <ac:chgData name="GARCIA GONZALEZ, PABLO" userId="a2e58272-c434-4247-ba31-462042e35682" providerId="ADAL" clId="{2D89B2DF-EA0F-4EF0-90B4-45D2CD0F1972}" dt="2024-08-30T10:11:14.220" v="14" actId="14100"/>
          <ac:picMkLst>
            <pc:docMk/>
            <pc:sldMk cId="4249151160" sldId="292"/>
            <ac:picMk id="5" creationId="{0237D3BF-8C24-8DA3-CFB9-AB654A36F4D5}"/>
          </ac:picMkLst>
        </pc:picChg>
      </pc:sldChg>
      <pc:sldChg chg="addSp delSp modSp new mod">
        <pc:chgData name="GARCIA GONZALEZ, PABLO" userId="a2e58272-c434-4247-ba31-462042e35682" providerId="ADAL" clId="{2D89B2DF-EA0F-4EF0-90B4-45D2CD0F1972}" dt="2024-09-02T11:24:32.060" v="560" actId="14100"/>
        <pc:sldMkLst>
          <pc:docMk/>
          <pc:sldMk cId="1662657956" sldId="293"/>
        </pc:sldMkLst>
        <pc:spChg chg="del">
          <ac:chgData name="GARCIA GONZALEZ, PABLO" userId="a2e58272-c434-4247-ba31-462042e35682" providerId="ADAL" clId="{2D89B2DF-EA0F-4EF0-90B4-45D2CD0F1972}" dt="2024-09-02T11:10:26.800" v="492" actId="478"/>
          <ac:spMkLst>
            <pc:docMk/>
            <pc:sldMk cId="1662657956" sldId="293"/>
            <ac:spMk id="2" creationId="{08FC1AA4-2ED8-F8CB-0525-B1CE50113684}"/>
          </ac:spMkLst>
        </pc:spChg>
        <pc:spChg chg="del">
          <ac:chgData name="GARCIA GONZALEZ, PABLO" userId="a2e58272-c434-4247-ba31-462042e35682" providerId="ADAL" clId="{2D89B2DF-EA0F-4EF0-90B4-45D2CD0F1972}" dt="2024-09-02T11:10:24.862" v="491" actId="478"/>
          <ac:spMkLst>
            <pc:docMk/>
            <pc:sldMk cId="1662657956" sldId="293"/>
            <ac:spMk id="3" creationId="{0B0C62C3-54D3-ACE7-B9D9-2DE602D1CC23}"/>
          </ac:spMkLst>
        </pc:spChg>
        <pc:spChg chg="add">
          <ac:chgData name="GARCIA GONZALEZ, PABLO" userId="a2e58272-c434-4247-ba31-462042e35682" providerId="ADAL" clId="{2D89B2DF-EA0F-4EF0-90B4-45D2CD0F1972}" dt="2024-09-02T11:10:20.282" v="488"/>
          <ac:spMkLst>
            <pc:docMk/>
            <pc:sldMk cId="1662657956" sldId="293"/>
            <ac:spMk id="4" creationId="{23D0536B-1975-28B0-DFD4-DF731B4ED74D}"/>
          </ac:spMkLst>
        </pc:spChg>
        <pc:spChg chg="add">
          <ac:chgData name="GARCIA GONZALEZ, PABLO" userId="a2e58272-c434-4247-ba31-462042e35682" providerId="ADAL" clId="{2D89B2DF-EA0F-4EF0-90B4-45D2CD0F1972}" dt="2024-09-02T11:14:36.798" v="497"/>
          <ac:spMkLst>
            <pc:docMk/>
            <pc:sldMk cId="1662657956" sldId="293"/>
            <ac:spMk id="6" creationId="{FE47FBF4-71DA-F157-EA94-CC3B8BE7311E}"/>
          </ac:spMkLst>
        </pc:spChg>
        <pc:spChg chg="add mod">
          <ac:chgData name="GARCIA GONZALEZ, PABLO" userId="a2e58272-c434-4247-ba31-462042e35682" providerId="ADAL" clId="{2D89B2DF-EA0F-4EF0-90B4-45D2CD0F1972}" dt="2024-09-02T11:15:29.904" v="554" actId="20577"/>
          <ac:spMkLst>
            <pc:docMk/>
            <pc:sldMk cId="1662657956" sldId="293"/>
            <ac:spMk id="8" creationId="{07E23215-20A3-CC28-C9D8-31A9F4BC5042}"/>
          </ac:spMkLst>
        </pc:spChg>
        <pc:picChg chg="add del mod">
          <ac:chgData name="GARCIA GONZALEZ, PABLO" userId="a2e58272-c434-4247-ba31-462042e35682" providerId="ADAL" clId="{2D89B2DF-EA0F-4EF0-90B4-45D2CD0F1972}" dt="2024-09-02T11:14:36.601" v="496" actId="478"/>
          <ac:picMkLst>
            <pc:docMk/>
            <pc:sldMk cId="1662657956" sldId="293"/>
            <ac:picMk id="5" creationId="{659B09FA-06BD-C7E7-6690-195694A7A292}"/>
          </ac:picMkLst>
        </pc:picChg>
        <pc:picChg chg="add mod">
          <ac:chgData name="GARCIA GONZALEZ, PABLO" userId="a2e58272-c434-4247-ba31-462042e35682" providerId="ADAL" clId="{2D89B2DF-EA0F-4EF0-90B4-45D2CD0F1972}" dt="2024-09-02T11:24:32.060" v="560" actId="14100"/>
          <ac:picMkLst>
            <pc:docMk/>
            <pc:sldMk cId="1662657956" sldId="293"/>
            <ac:picMk id="7" creationId="{5E9A9770-4CAF-DCE9-6CBF-A38F8DC633A0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3D9733-37B6-4FD1-B676-CE9D97B28CAD}" type="datetimeFigureOut">
              <a:rPr lang="en-GB" smtClean="0"/>
              <a:t>02/02/2026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C3CDE-2EE6-4A2A-ADE9-F3C00A12E5B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39548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22313-C28D-47AB-8796-09B6D5B45D69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661002-E624-4880-A01C-E97E21AD43F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102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661002-E624-4880-A01C-E97E21AD43F5}" type="slidenum">
              <a:rPr lang="es-ES" smtClean="0"/>
              <a:t>1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06699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95312"/>
            <a:ext cx="10363200" cy="424462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403623"/>
            <a:ext cx="9144000" cy="294357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8966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7835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49111"/>
            <a:ext cx="2628900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49111"/>
            <a:ext cx="7734300" cy="10332156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3043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1847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039537"/>
            <a:ext cx="10515600" cy="5071532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159048"/>
            <a:ext cx="10515600" cy="2666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4279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245556"/>
            <a:ext cx="5181600" cy="7735712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245556"/>
            <a:ext cx="5181600" cy="7735712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1117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49114"/>
            <a:ext cx="10515600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88734"/>
            <a:ext cx="5157787" cy="146473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453467"/>
            <a:ext cx="5157787" cy="6550379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88734"/>
            <a:ext cx="5183188" cy="146473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453467"/>
            <a:ext cx="5183188" cy="6550379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6703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6707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7400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2800"/>
            <a:ext cx="3932237" cy="28448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55425"/>
            <a:ext cx="6172200" cy="866422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57600"/>
            <a:ext cx="3932237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6292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2800"/>
            <a:ext cx="3932237" cy="28448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55425"/>
            <a:ext cx="6172200" cy="866422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57600"/>
            <a:ext cx="3932237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316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49114"/>
            <a:ext cx="105156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245556"/>
            <a:ext cx="105156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300181"/>
            <a:ext cx="27432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98239-97CD-48D1-B502-AE200F18EB4B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300181"/>
            <a:ext cx="41148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300181"/>
            <a:ext cx="27432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FAB09-CD4E-4257-97DC-F76CACB317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4252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252" y="1972580"/>
            <a:ext cx="6000750" cy="3705225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252" y="5393697"/>
            <a:ext cx="6000750" cy="3705225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8347" y="1972580"/>
            <a:ext cx="6000750" cy="3705225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68347" y="5393697"/>
            <a:ext cx="6000750" cy="3705225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581167" y="1044985"/>
            <a:ext cx="103363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igure 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LASSO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regressions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sult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itting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lipidomi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C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to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ir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spective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mi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MSV. 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0231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/>
          <p:cNvSpPr/>
          <p:nvPr/>
        </p:nvSpPr>
        <p:spPr>
          <a:xfrm>
            <a:off x="672437" y="144244"/>
            <a:ext cx="1049724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10. Distribution of the proteomics PC2 based on PRS </a:t>
            </a:r>
            <a:r>
              <a:rPr lang="en-GB" sz="16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ertiles</a:t>
            </a:r>
            <a:r>
              <a:rPr lang="en-GB" sz="16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or hypertension (systolic, diastolic, and pulse pressure) and stroke (any, any ischaemic, small vessel, large artery atherosclerotic, and </a:t>
            </a:r>
            <a:r>
              <a:rPr lang="en-GB" sz="16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ardioembolic</a:t>
            </a:r>
            <a:r>
              <a:rPr lang="en-GB" sz="16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stroke. </a:t>
            </a:r>
            <a:r>
              <a:rPr lang="en-US" sz="1600" dirty="0">
                <a:latin typeface="Helvetica" panose="020B0604020202020204" pitchFamily="34" charset="0"/>
                <a:cs typeface="Helvetica" panose="020B0604020202020204" pitchFamily="34" charset="0"/>
              </a:rPr>
              <a:t>P-values were derived from pairwise two-sided Welch’s t-tests.</a:t>
            </a:r>
            <a:endParaRPr lang="en-GB" sz="1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8" name="Imagen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18"/>
          <a:stretch/>
        </p:blipFill>
        <p:spPr>
          <a:xfrm>
            <a:off x="237055" y="1617662"/>
            <a:ext cx="3454217" cy="3208341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77"/>
          <a:stretch/>
        </p:blipFill>
        <p:spPr>
          <a:xfrm>
            <a:off x="3894662" y="1581680"/>
            <a:ext cx="3454217" cy="3244321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58"/>
          <a:stretch/>
        </p:blipFill>
        <p:spPr>
          <a:xfrm>
            <a:off x="7743364" y="1608667"/>
            <a:ext cx="3454217" cy="3217334"/>
          </a:xfrm>
          <a:prstGeom prst="rect">
            <a:avLst/>
          </a:prstGeom>
        </p:spPr>
      </p:pic>
      <p:sp>
        <p:nvSpPr>
          <p:cNvPr id="21" name="CuadroTexto 20"/>
          <p:cNvSpPr txBox="1"/>
          <p:nvPr/>
        </p:nvSpPr>
        <p:spPr>
          <a:xfrm>
            <a:off x="967094" y="1099789"/>
            <a:ext cx="2724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stolic blood pressur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2" name="CuadroTexto 21"/>
          <p:cNvSpPr txBox="1"/>
          <p:nvPr/>
        </p:nvSpPr>
        <p:spPr>
          <a:xfrm>
            <a:off x="4624701" y="1099788"/>
            <a:ext cx="2724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iastolic blood pressur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8875371" y="1107394"/>
            <a:ext cx="1961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ulse pressur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44"/>
          <a:stretch/>
        </p:blipFill>
        <p:spPr>
          <a:xfrm>
            <a:off x="368840" y="5044584"/>
            <a:ext cx="3454217" cy="3214343"/>
          </a:xfrm>
          <a:prstGeom prst="rect">
            <a:avLst/>
          </a:prstGeom>
        </p:spPr>
      </p:pic>
      <p:pic>
        <p:nvPicPr>
          <p:cNvPr id="25" name="Imagen 2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10"/>
          <a:stretch/>
        </p:blipFill>
        <p:spPr>
          <a:xfrm>
            <a:off x="4056102" y="5128795"/>
            <a:ext cx="3454217" cy="3205161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63"/>
          <a:stretch/>
        </p:blipFill>
        <p:spPr>
          <a:xfrm>
            <a:off x="7743364" y="5116801"/>
            <a:ext cx="3454217" cy="3217156"/>
          </a:xfrm>
          <a:prstGeom prst="rect">
            <a:avLst/>
          </a:prstGeom>
        </p:spPr>
      </p:pic>
      <p:pic>
        <p:nvPicPr>
          <p:cNvPr id="27" name="Imagen 2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10"/>
          <a:stretch/>
        </p:blipFill>
        <p:spPr>
          <a:xfrm>
            <a:off x="455573" y="8842588"/>
            <a:ext cx="3454217" cy="3205167"/>
          </a:xfrm>
          <a:prstGeom prst="rect">
            <a:avLst/>
          </a:prstGeom>
        </p:spPr>
      </p:pic>
      <p:sp>
        <p:nvSpPr>
          <p:cNvPr id="29" name="CuadroTexto 28"/>
          <p:cNvSpPr txBox="1"/>
          <p:nvPr/>
        </p:nvSpPr>
        <p:spPr>
          <a:xfrm>
            <a:off x="1363442" y="4807160"/>
            <a:ext cx="16168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ny strok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4664705" y="4860939"/>
            <a:ext cx="2773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ny ischaemic strok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" name="CuadroTexto 30"/>
          <p:cNvSpPr txBox="1"/>
          <p:nvPr/>
        </p:nvSpPr>
        <p:spPr>
          <a:xfrm>
            <a:off x="8597912" y="4834871"/>
            <a:ext cx="23805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mall vessel strok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CuadroTexto 31"/>
          <p:cNvSpPr txBox="1"/>
          <p:nvPr/>
        </p:nvSpPr>
        <p:spPr>
          <a:xfrm>
            <a:off x="764549" y="8428558"/>
            <a:ext cx="3581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arge artery atherosclerotic strok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3" name="Imagen 3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95"/>
          <a:stretch/>
        </p:blipFill>
        <p:spPr>
          <a:xfrm>
            <a:off x="4289147" y="8808698"/>
            <a:ext cx="3454217" cy="3216065"/>
          </a:xfrm>
          <a:prstGeom prst="rect">
            <a:avLst/>
          </a:prstGeom>
        </p:spPr>
      </p:pic>
      <p:sp>
        <p:nvSpPr>
          <p:cNvPr id="35" name="CuadroTexto 34"/>
          <p:cNvSpPr txBox="1"/>
          <p:nvPr/>
        </p:nvSpPr>
        <p:spPr>
          <a:xfrm>
            <a:off x="5145585" y="8428558"/>
            <a:ext cx="2626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ardioembolic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stroke PR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293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8985" y="2444618"/>
            <a:ext cx="3786555" cy="2679405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2452072" y="2075285"/>
            <a:ext cx="11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 smtClean="0"/>
              <a:t>ContJ_CSF</a:t>
            </a:r>
            <a:endParaRPr lang="en-GB" b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25540" y="2446185"/>
            <a:ext cx="3673459" cy="2679405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6144407" y="2041325"/>
            <a:ext cx="1235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 smtClean="0"/>
              <a:t>ContN_CSF</a:t>
            </a:r>
            <a:endParaRPr lang="en-GB" b="1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5365" y="5390918"/>
            <a:ext cx="3832474" cy="2756876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2412797" y="5047492"/>
            <a:ext cx="1238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 smtClean="0"/>
              <a:t>ContO_CSF</a:t>
            </a:r>
            <a:endParaRPr lang="en-GB" b="1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77839" y="5376680"/>
            <a:ext cx="3812886" cy="2771114"/>
          </a:xfrm>
          <a:prstGeom prst="rect">
            <a:avLst/>
          </a:prstGeom>
        </p:spPr>
      </p:pic>
      <p:sp>
        <p:nvSpPr>
          <p:cNvPr id="11" name="CuadroTexto 10"/>
          <p:cNvSpPr txBox="1"/>
          <p:nvPr/>
        </p:nvSpPr>
        <p:spPr>
          <a:xfrm>
            <a:off x="6141278" y="5005916"/>
            <a:ext cx="1197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 smtClean="0"/>
              <a:t>ContT_CSF</a:t>
            </a:r>
            <a:endParaRPr lang="en-GB" b="1" dirty="0"/>
          </a:p>
        </p:txBody>
      </p:sp>
      <p:sp>
        <p:nvSpPr>
          <p:cNvPr id="12" name="Rectángulo 11"/>
          <p:cNvSpPr/>
          <p:nvPr/>
        </p:nvSpPr>
        <p:spPr>
          <a:xfrm>
            <a:off x="565036" y="505624"/>
            <a:ext cx="10497242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11. PCA results in GNPC cohorts 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tandardized 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values of 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SF proteomics data (</a:t>
            </a:r>
            <a:r>
              <a:rPr lang="en-GB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omascan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) in GNPC, stratified by contributing </a:t>
            </a:r>
            <a:r>
              <a:rPr lang="en-GB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enter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Rows represent samples, sorted by their mean standardized intensities. Columns represent 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rotein 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species, sorted by z-values derived from linear regressions fitting each </a:t>
            </a:r>
            <a:r>
              <a:rPr lang="en-GB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omamer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to the mean standardized intensity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b. </a:t>
            </a:r>
            <a:r>
              <a:rPr lang="en-US" dirty="0">
                <a:latin typeface="Helvetica" panose="020B0604020202020204" pitchFamily="34" charset="0"/>
                <a:cs typeface="Helvetica" panose="020B0604020202020204" pitchFamily="34" charset="0"/>
              </a:rPr>
              <a:t>Variance explained (%) by the first four proteomics </a:t>
            </a:r>
            <a:r>
              <a:rPr lang="en-U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Cs in GNPC cohorts.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3" name="Imagen 1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8743" y="8413122"/>
            <a:ext cx="7727139" cy="3341094"/>
          </a:xfrm>
          <a:prstGeom prst="rect">
            <a:avLst/>
          </a:prstGeom>
        </p:spPr>
      </p:pic>
      <p:sp>
        <p:nvSpPr>
          <p:cNvPr id="14" name="Rectángulo 13"/>
          <p:cNvSpPr/>
          <p:nvPr/>
        </p:nvSpPr>
        <p:spPr>
          <a:xfrm>
            <a:off x="558572" y="2041325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.</a:t>
            </a:r>
            <a:endParaRPr lang="en-GB" dirty="0"/>
          </a:p>
        </p:txBody>
      </p:sp>
      <p:sp>
        <p:nvSpPr>
          <p:cNvPr id="15" name="Rectángulo 14"/>
          <p:cNvSpPr/>
          <p:nvPr/>
        </p:nvSpPr>
        <p:spPr>
          <a:xfrm>
            <a:off x="558572" y="8413122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5056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672437" y="144244"/>
            <a:ext cx="1049724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12. CSF/plasma PCA comparison in GNPC paired samples (N=1689). 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.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rrelation between mean standardized values (MSV) and PCs1-4 in paired GNPC CSF-EDTA plasma samples. b-c. Correlation between CSF and plasma levels of OPCML (top CSF PC1 reference marker) and CFP (top CSF PC2 reference marker).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425"/>
          <a:stretch/>
        </p:blipFill>
        <p:spPr>
          <a:xfrm>
            <a:off x="219179" y="2208798"/>
            <a:ext cx="6431267" cy="5402292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30479" y="5071446"/>
            <a:ext cx="4806269" cy="2403135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0479" y="2000198"/>
            <a:ext cx="5147187" cy="2573593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7771955" y="1630866"/>
            <a:ext cx="3734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OPCML </a:t>
            </a:r>
            <a:r>
              <a:rPr lang="en-GB" b="1" dirty="0" smtClean="0"/>
              <a:t>(seq.15622.13) CSF vs plasma</a:t>
            </a:r>
            <a:endParaRPr lang="en-GB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7462829" y="4573791"/>
            <a:ext cx="3268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FP (seq.2960.66)</a:t>
            </a:r>
            <a:r>
              <a:rPr lang="en-GB" b="1" dirty="0" smtClean="0"/>
              <a:t> CSF vs plasma</a:t>
            </a:r>
            <a:endParaRPr lang="en-GB" b="1" dirty="0"/>
          </a:p>
        </p:txBody>
      </p:sp>
      <p:sp>
        <p:nvSpPr>
          <p:cNvPr id="10" name="Rectángulo 9"/>
          <p:cNvSpPr/>
          <p:nvPr/>
        </p:nvSpPr>
        <p:spPr>
          <a:xfrm>
            <a:off x="219179" y="1630866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endParaRPr lang="en-GB" dirty="0"/>
          </a:p>
        </p:txBody>
      </p:sp>
      <p:sp>
        <p:nvSpPr>
          <p:cNvPr id="11" name="Rectángulo 10"/>
          <p:cNvSpPr/>
          <p:nvPr/>
        </p:nvSpPr>
        <p:spPr>
          <a:xfrm>
            <a:off x="6741966" y="1630866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.</a:t>
            </a:r>
            <a:endParaRPr lang="en-GB" dirty="0"/>
          </a:p>
        </p:txBody>
      </p:sp>
      <p:sp>
        <p:nvSpPr>
          <p:cNvPr id="14" name="Rectángulo 13"/>
          <p:cNvSpPr/>
          <p:nvPr/>
        </p:nvSpPr>
        <p:spPr>
          <a:xfrm>
            <a:off x="6741966" y="4637952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325975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72D83066-F596-36FC-434E-443B04AE06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690" y="3225800"/>
            <a:ext cx="5716643" cy="4302369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0237D3BF-8C24-8DA3-CFB9-AB654A36F4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91610" y="3225800"/>
            <a:ext cx="6025164" cy="4302368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C7AB300D-6A11-4F22-9377-EFFD6D8FC09E}"/>
              </a:ext>
            </a:extLst>
          </p:cNvPr>
          <p:cNvSpPr txBox="1"/>
          <p:nvPr/>
        </p:nvSpPr>
        <p:spPr>
          <a:xfrm>
            <a:off x="524369" y="437071"/>
            <a:ext cx="1139240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igure 13. CSF lipidomics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producibility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ssessment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blue line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displays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mean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sample-sampl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correlation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when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keeping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lipids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a Pearson R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coefficient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higher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an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alue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n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x-axis,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whil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red line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es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proportion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lipids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remaining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in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dataset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after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removing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hes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species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.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Proportion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lipids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classified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as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ad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intermediat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r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good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reproducibility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lipid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dirty="0" err="1">
                <a:latin typeface="Helvetica" panose="020B0604020202020204" pitchFamily="34" charset="0"/>
                <a:cs typeface="Helvetica" panose="020B0604020202020204" pitchFamily="34" charset="0"/>
              </a:rPr>
              <a:t>type</a:t>
            </a:r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</a:p>
          <a:p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" name="Rectángulo 6"/>
          <p:cNvSpPr/>
          <p:nvPr/>
        </p:nvSpPr>
        <p:spPr>
          <a:xfrm>
            <a:off x="106177" y="2702649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.</a:t>
            </a:r>
            <a:endParaRPr lang="en-GB" dirty="0"/>
          </a:p>
        </p:txBody>
      </p:sp>
      <p:sp>
        <p:nvSpPr>
          <p:cNvPr id="8" name="Rectángulo 7"/>
          <p:cNvSpPr/>
          <p:nvPr/>
        </p:nvSpPr>
        <p:spPr>
          <a:xfrm>
            <a:off x="6786377" y="2702649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60190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22"/>
          <a:stretch/>
        </p:blipFill>
        <p:spPr>
          <a:xfrm>
            <a:off x="8600481" y="2270232"/>
            <a:ext cx="3394028" cy="8171791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48"/>
          <a:stretch/>
        </p:blipFill>
        <p:spPr>
          <a:xfrm>
            <a:off x="-56979" y="2270233"/>
            <a:ext cx="4985935" cy="8171791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57"/>
          <a:stretch/>
        </p:blipFill>
        <p:spPr>
          <a:xfrm>
            <a:off x="4928956" y="2270233"/>
            <a:ext cx="3483827" cy="817179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5222879" y="1864760"/>
            <a:ext cx="1447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i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C1</a:t>
            </a:r>
            <a:r>
              <a:rPr lang="es-ES" sz="1600" i="1" baseline="-25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lip</a:t>
            </a:r>
            <a:endParaRPr lang="es-ES" sz="1600" i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8600481" y="1858271"/>
            <a:ext cx="1447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i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C2</a:t>
            </a:r>
            <a:r>
              <a:rPr lang="es-ES" sz="1600" i="1" baseline="-25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lip</a:t>
            </a:r>
            <a:endParaRPr lang="es-ES" sz="1600" i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1845277" y="1892875"/>
            <a:ext cx="1447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i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SV</a:t>
            </a:r>
            <a:r>
              <a:rPr lang="es-ES" sz="1600" i="1" baseline="-25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lip</a:t>
            </a:r>
            <a:endParaRPr lang="es-ES" sz="1600" i="1" baseline="-25000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522174" y="417533"/>
            <a:ext cx="103363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Figure 2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ssociatio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cilliary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easurement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rom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aired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CSF/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erum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lood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ell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unt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lipidomics MSV, PC1 and PC2 .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odel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er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usted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g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sex. 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34398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49"/>
          <a:stretch/>
        </p:blipFill>
        <p:spPr>
          <a:xfrm>
            <a:off x="8524352" y="2292016"/>
            <a:ext cx="3360818" cy="8008984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24"/>
          <a:stretch/>
        </p:blipFill>
        <p:spPr>
          <a:xfrm>
            <a:off x="163714" y="2292016"/>
            <a:ext cx="4888070" cy="8008985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95"/>
          <a:stretch/>
        </p:blipFill>
        <p:spPr>
          <a:xfrm>
            <a:off x="5211730" y="2292016"/>
            <a:ext cx="3334038" cy="8008983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5168166" y="1925346"/>
            <a:ext cx="1447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i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C1</a:t>
            </a:r>
            <a:r>
              <a:rPr lang="es-ES" sz="1600" i="1" baseline="-25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endParaRPr lang="es-ES" sz="1600" i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8545768" y="1918857"/>
            <a:ext cx="1447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i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C2</a:t>
            </a:r>
            <a:r>
              <a:rPr lang="es-ES" sz="1600" i="1" baseline="-25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endParaRPr lang="es-ES" sz="1600" i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1790564" y="1905335"/>
            <a:ext cx="1447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i="1" dirty="0" err="1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SV</a:t>
            </a:r>
            <a:r>
              <a:rPr lang="es-ES" sz="1600" i="1" baseline="-25000" dirty="0" err="1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endParaRPr lang="es-ES" sz="1600" i="1" baseline="-25000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570300" y="690249"/>
            <a:ext cx="103363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Figure 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.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ssociation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ncilliary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measurements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from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aired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CSF/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erum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blood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cell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counts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MSV, PC1 and PC2 .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odel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er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usted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g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sex. 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54744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772" y="1838058"/>
            <a:ext cx="12022228" cy="6182588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570300" y="690249"/>
            <a:ext cx="103363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ure 4.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rai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ingle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nuclei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GMNC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Human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i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tlas)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ccessed</a:t>
            </a:r>
            <a:r>
              <a:rPr lang="es-E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07 Feb 2025.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4221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6260" y="8580770"/>
            <a:ext cx="4422382" cy="301526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6260" y="5188139"/>
            <a:ext cx="4397977" cy="2998620"/>
          </a:xfrm>
          <a:prstGeom prst="rect">
            <a:avLst/>
          </a:prstGeom>
        </p:spPr>
      </p:pic>
      <p:sp>
        <p:nvSpPr>
          <p:cNvPr id="10" name="CuadroTexto 9"/>
          <p:cNvSpPr txBox="1"/>
          <p:nvPr/>
        </p:nvSpPr>
        <p:spPr>
          <a:xfrm>
            <a:off x="142169" y="177097"/>
            <a:ext cx="1177206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igure 5. VVIA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ignature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mpariso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cros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issue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(CSF,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rai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Plasma). </a:t>
            </a:r>
            <a:r>
              <a:rPr lang="es-ES" i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Heatmap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isplaying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Pearson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rrelation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(R)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or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VVIA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ignatur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(z-scores)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etween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CE CSF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alidation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abl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8). b-d.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catterplot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howing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z-score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rrelation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of VVIA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ignature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mparing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CE CSF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alidation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CSF,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rain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plasma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s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spectively</a:t>
            </a:r>
            <a:r>
              <a:rPr lang="es-ES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endParaRPr lang="es-ES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1238802" y="1838450"/>
            <a:ext cx="4224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omascan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z-score correlation matrix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92"/>
          <a:stretch/>
        </p:blipFill>
        <p:spPr>
          <a:xfrm>
            <a:off x="7450891" y="1940787"/>
            <a:ext cx="4463347" cy="2869981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7965088" y="1477798"/>
            <a:ext cx="3565693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CE CSF vs CSF </a:t>
            </a:r>
            <a:r>
              <a:rPr lang="es-ES" sz="12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plication</a:t>
            </a:r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z-scores</a:t>
            </a:r>
          </a:p>
          <a:p>
            <a:pPr algn="ctr"/>
            <a:r>
              <a:rPr lang="es-ES" sz="105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ADNI/DIAN/MARS/Barcelona-1/PPMI/Stanford</a:t>
            </a:r>
            <a:r>
              <a:rPr lang="es-ES" sz="1050" b="1" i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8153773" y="4902824"/>
            <a:ext cx="3565693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CE CSF vs </a:t>
            </a:r>
            <a:r>
              <a:rPr lang="es-ES" sz="12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rain</a:t>
            </a:r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2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plication</a:t>
            </a:r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CSF z-scores</a:t>
            </a:r>
          </a:p>
          <a:p>
            <a:pPr algn="ctr"/>
            <a:r>
              <a:rPr lang="es-ES" sz="105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s-ES" sz="105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Knight</a:t>
            </a:r>
            <a:r>
              <a:rPr lang="es-ES" sz="105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DRC)</a:t>
            </a:r>
            <a:endParaRPr lang="es-ES" sz="105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8153773" y="8223240"/>
            <a:ext cx="3565693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CE CSF vs Plasma </a:t>
            </a:r>
            <a:r>
              <a:rPr lang="es-ES" sz="12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plication</a:t>
            </a:r>
            <a:r>
              <a:rPr lang="es-ES" sz="12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CSF z-scores</a:t>
            </a:r>
          </a:p>
          <a:p>
            <a:pPr algn="ctr"/>
            <a:r>
              <a:rPr lang="es-ES" sz="105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s-ES" sz="105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Knight</a:t>
            </a:r>
            <a:r>
              <a:rPr lang="es-ES" sz="105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DRC)</a:t>
            </a:r>
            <a:endParaRPr lang="es-ES" sz="105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51810" y="1660006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.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7262378" y="161346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CuadroTexto 14"/>
          <p:cNvSpPr txBox="1"/>
          <p:nvPr/>
        </p:nvSpPr>
        <p:spPr>
          <a:xfrm>
            <a:off x="7359764" y="492145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CuadroTexto 15"/>
          <p:cNvSpPr txBox="1"/>
          <p:nvPr/>
        </p:nvSpPr>
        <p:spPr>
          <a:xfrm>
            <a:off x="7334159" y="8275309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.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5"/>
          <a:srcRect t="2745"/>
          <a:stretch/>
        </p:blipFill>
        <p:spPr>
          <a:xfrm>
            <a:off x="156493" y="2227149"/>
            <a:ext cx="7697479" cy="7486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3681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o 11"/>
          <p:cNvGrpSpPr>
            <a:grpSpLocks noChangeAspect="1"/>
          </p:cNvGrpSpPr>
          <p:nvPr/>
        </p:nvGrpSpPr>
        <p:grpSpPr>
          <a:xfrm>
            <a:off x="2093928" y="1700312"/>
            <a:ext cx="8835330" cy="8272155"/>
            <a:chOff x="1081799" y="808851"/>
            <a:chExt cx="5852234" cy="5479205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00"/>
            <a:stretch/>
          </p:blipFill>
          <p:spPr>
            <a:xfrm>
              <a:off x="1081799" y="1085850"/>
              <a:ext cx="5852234" cy="5202206"/>
            </a:xfrm>
            <a:prstGeom prst="rect">
              <a:avLst/>
            </a:prstGeom>
          </p:spPr>
        </p:pic>
        <p:sp>
          <p:nvSpPr>
            <p:cNvPr id="11" name="CuadroTexto 10"/>
            <p:cNvSpPr txBox="1"/>
            <p:nvPr/>
          </p:nvSpPr>
          <p:spPr>
            <a:xfrm>
              <a:off x="1933575" y="808851"/>
              <a:ext cx="2705035" cy="2422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Metabolon z-score correlation matrix</a:t>
              </a:r>
              <a:endParaRPr lang="en-GB" sz="16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2" name="Rectángulo 1"/>
          <p:cNvSpPr/>
          <p:nvPr/>
        </p:nvSpPr>
        <p:spPr>
          <a:xfrm>
            <a:off x="725714" y="616098"/>
            <a:ext cx="11176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Figure 6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VVIA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etabolomi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ignature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comparison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cross</a:t>
            </a:r>
            <a:r>
              <a:rPr lang="es-ES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SF (ADNI/DIAN/ Barcelona-1/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KnightADR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),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rai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(DIAN/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KnightADRC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/ROSMAP/Mayo) and Plasma (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Knight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DRC) in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alidation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s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able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8). 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endParaRPr lang="es-ES" b="1" i="1" dirty="0" smtClean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7638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671060" y="261478"/>
            <a:ext cx="10652869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600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 Figure 7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Beta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mparison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or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ssociation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each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omaScan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alyte (N=2395)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omaScan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Lipometrix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PC1 and PC2 in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CE CSF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p up- and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ownregulat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in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as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etermin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invers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arianc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eight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ixed</a:t>
            </a:r>
            <a:r>
              <a:rPr lang="es-ES" sz="16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effec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r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andom</a:t>
            </a:r>
            <a:r>
              <a:rPr lang="es-ES" sz="16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effec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meta-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alysi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er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highlight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andom-effec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etaanalysi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estimate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llow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identification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os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arker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os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nsistently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ssociat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lipidomics PC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unterpart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hil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in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mparison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fixed-effec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tatistic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ioritiz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os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tronges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ssociation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C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</a:p>
          <a:p>
            <a:endParaRPr lang="es-E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24" name="Grupo 23"/>
          <p:cNvGrpSpPr/>
          <p:nvPr/>
        </p:nvGrpSpPr>
        <p:grpSpPr>
          <a:xfrm>
            <a:off x="1725613" y="2013084"/>
            <a:ext cx="7955416" cy="8057561"/>
            <a:chOff x="1725613" y="1998570"/>
            <a:chExt cx="7955416" cy="8057561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/>
            <a:srcRect l="11453" t="10545" r="47246" b="77397"/>
            <a:stretch/>
          </p:blipFill>
          <p:spPr>
            <a:xfrm>
              <a:off x="5013620" y="1998570"/>
              <a:ext cx="1967750" cy="612148"/>
            </a:xfrm>
            <a:prstGeom prst="rect">
              <a:avLst/>
            </a:prstGeom>
          </p:spPr>
        </p:pic>
        <p:pic>
          <p:nvPicPr>
            <p:cNvPr id="20" name="Imagen 19"/>
            <p:cNvPicPr>
              <a:picLocks noChangeAspect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8629" y="6074679"/>
              <a:ext cx="3962400" cy="3962400"/>
            </a:xfrm>
            <a:prstGeom prst="rect">
              <a:avLst/>
            </a:prstGeom>
          </p:spPr>
        </p:pic>
        <p:pic>
          <p:nvPicPr>
            <p:cNvPr id="21" name="Imagen 20"/>
            <p:cNvPicPr>
              <a:picLocks noChangeAspect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25613" y="2310039"/>
              <a:ext cx="3962400" cy="3962400"/>
            </a:xfrm>
            <a:prstGeom prst="rect">
              <a:avLst/>
            </a:prstGeom>
          </p:spPr>
        </p:pic>
        <p:pic>
          <p:nvPicPr>
            <p:cNvPr id="22" name="Imagen 21"/>
            <p:cNvPicPr>
              <a:picLocks noChangeAspect="1"/>
            </p:cNvPicPr>
            <p:nvPr/>
          </p:nvPicPr>
          <p:blipFill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25613" y="6093731"/>
              <a:ext cx="3962400" cy="3962400"/>
            </a:xfrm>
            <a:prstGeom prst="rect">
              <a:avLst/>
            </a:prstGeom>
          </p:spPr>
        </p:pic>
        <p:pic>
          <p:nvPicPr>
            <p:cNvPr id="23" name="Imagen 22"/>
            <p:cNvPicPr>
              <a:picLocks noChangeAspect="1"/>
            </p:cNvPicPr>
            <p:nvPr/>
          </p:nvPicPr>
          <p:blipFill>
            <a:blip r:embed="rId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8629" y="2310039"/>
              <a:ext cx="3962400" cy="39624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281632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n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5101" y="2234894"/>
            <a:ext cx="6806968" cy="6806968"/>
          </a:xfrm>
          <a:prstGeom prst="rect">
            <a:avLst/>
          </a:prstGeom>
        </p:spPr>
      </p:pic>
      <p:sp>
        <p:nvSpPr>
          <p:cNvPr id="6" name="Rectángulo 5"/>
          <p:cNvSpPr/>
          <p:nvPr/>
        </p:nvSpPr>
        <p:spPr>
          <a:xfrm>
            <a:off x="637430" y="87306"/>
            <a:ext cx="1065286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600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ementary</a:t>
            </a:r>
            <a:r>
              <a:rPr lang="es-ES" sz="16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 Figure 8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enn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iagram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isplaying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verlap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etween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PC1 and PC2 up- and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ownregulated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ins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in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CE CSF </a:t>
            </a:r>
            <a:r>
              <a:rPr lang="es-ES" sz="1600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hort</a:t>
            </a:r>
            <a:r>
              <a:rPr lang="es-ES" sz="16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in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gulat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PC1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r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PC2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er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defin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s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os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DR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ust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p-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valu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&lt; 0.05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based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on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he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andom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effect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meta-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nalysi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combining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roteomic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and lipidomics PC </a:t>
            </a:r>
            <a:r>
              <a:rPr lang="es-ES" sz="16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results</a:t>
            </a:r>
            <a:r>
              <a:rPr lang="es-ES" sz="16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endParaRPr lang="es-ES" sz="1600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5332660" y="2234894"/>
            <a:ext cx="2885089" cy="365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DR </a:t>
            </a:r>
            <a:r>
              <a:rPr lang="es-ES" b="1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pval</a:t>
            </a:r>
            <a:r>
              <a:rPr lang="es-ES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&lt; 0.05</a:t>
            </a:r>
            <a:endParaRPr lang="es-ES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4747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308" y="1636340"/>
            <a:ext cx="3737774" cy="3737774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1749" y="1628791"/>
            <a:ext cx="3739253" cy="3739253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4669" y="1636340"/>
            <a:ext cx="3739253" cy="3739253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137" y="5945420"/>
            <a:ext cx="3736800" cy="3736800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202" y="5945420"/>
            <a:ext cx="3736800" cy="3736800"/>
          </a:xfrm>
          <a:prstGeom prst="rect">
            <a:avLst/>
          </a:prstGeom>
        </p:spPr>
      </p:pic>
      <p:sp>
        <p:nvSpPr>
          <p:cNvPr id="10" name="Rectángulo 9"/>
          <p:cNvSpPr/>
          <p:nvPr/>
        </p:nvSpPr>
        <p:spPr>
          <a:xfrm>
            <a:off x="1374096" y="1280447"/>
            <a:ext cx="29676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erebrovascular accident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Rectángulo 10"/>
          <p:cNvSpPr/>
          <p:nvPr/>
        </p:nvSpPr>
        <p:spPr>
          <a:xfrm>
            <a:off x="5681937" y="1280447"/>
            <a:ext cx="15524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ardiopathy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Rectángulo 11"/>
          <p:cNvSpPr/>
          <p:nvPr/>
        </p:nvSpPr>
        <p:spPr>
          <a:xfrm>
            <a:off x="9837231" y="1309689"/>
            <a:ext cx="15524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iabetes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Rectángulo 12"/>
          <p:cNvSpPr/>
          <p:nvPr/>
        </p:nvSpPr>
        <p:spPr>
          <a:xfrm>
            <a:off x="1638028" y="5597076"/>
            <a:ext cx="22523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Hypertension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Rectángulo 13"/>
          <p:cNvSpPr/>
          <p:nvPr/>
        </p:nvSpPr>
        <p:spPr>
          <a:xfrm>
            <a:off x="5331988" y="5597076"/>
            <a:ext cx="22523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nal insufficiency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Rectángulo 14"/>
          <p:cNvSpPr/>
          <p:nvPr/>
        </p:nvSpPr>
        <p:spPr>
          <a:xfrm>
            <a:off x="649729" y="270648"/>
            <a:ext cx="1049724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</a:t>
            </a:r>
            <a:r>
              <a:rPr lang="en-GB" sz="1600" b="1" dirty="0">
                <a:latin typeface="Helvetica" panose="020B0604020202020204" pitchFamily="34" charset="0"/>
                <a:cs typeface="Helvetica" panose="020B0604020202020204" pitchFamily="34" charset="0"/>
              </a:rPr>
              <a:t>9</a:t>
            </a:r>
            <a:r>
              <a:rPr lang="en-GB" sz="16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Association of proteomics and lipidomics PC1 and PC2 to patient history of cerebrovascular accident (AVC), cardiopathy, diabetes, hypertension and renal insufficiency, and with CSF red blood cell blood count.</a:t>
            </a:r>
            <a:r>
              <a:rPr lang="en-GB" sz="1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600" dirty="0">
                <a:latin typeface="Helvetica" panose="020B0604020202020204" pitchFamily="34" charset="0"/>
                <a:cs typeface="Helvetica" panose="020B0604020202020204" pitchFamily="34" charset="0"/>
              </a:rPr>
              <a:t>P-values were derived from pairwise two-sided Welch’s </a:t>
            </a:r>
            <a:r>
              <a:rPr lang="en-US" sz="1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-tests.</a:t>
            </a:r>
            <a:endParaRPr lang="en-GB" sz="1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3" name="Grupo 2"/>
          <p:cNvGrpSpPr/>
          <p:nvPr/>
        </p:nvGrpSpPr>
        <p:grpSpPr>
          <a:xfrm>
            <a:off x="8167895" y="5637643"/>
            <a:ext cx="3816328" cy="3918096"/>
            <a:chOff x="8167895" y="5637643"/>
            <a:chExt cx="3816328" cy="3918096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7"/>
            <a:srcRect r="24807"/>
            <a:stretch/>
          </p:blipFill>
          <p:spPr>
            <a:xfrm>
              <a:off x="8167895" y="6416545"/>
              <a:ext cx="3816328" cy="3139194"/>
            </a:xfrm>
            <a:prstGeom prst="rect">
              <a:avLst/>
            </a:prstGeom>
          </p:spPr>
        </p:pic>
        <p:pic>
          <p:nvPicPr>
            <p:cNvPr id="18" name="Imagen 17"/>
            <p:cNvPicPr>
              <a:picLocks noChangeAspect="1"/>
            </p:cNvPicPr>
            <p:nvPr/>
          </p:nvPicPr>
          <p:blipFill rotWithShape="1">
            <a:blip r:embed="rId7"/>
            <a:srcRect l="74862" t="40472" r="16712" b="53919"/>
            <a:stretch/>
          </p:blipFill>
          <p:spPr>
            <a:xfrm>
              <a:off x="9271188" y="6115994"/>
              <a:ext cx="507822" cy="209103"/>
            </a:xfrm>
            <a:prstGeom prst="rect">
              <a:avLst/>
            </a:prstGeom>
          </p:spPr>
        </p:pic>
        <p:pic>
          <p:nvPicPr>
            <p:cNvPr id="19" name="Imagen 18"/>
            <p:cNvPicPr>
              <a:picLocks noChangeAspect="1"/>
            </p:cNvPicPr>
            <p:nvPr/>
          </p:nvPicPr>
          <p:blipFill rotWithShape="1">
            <a:blip r:embed="rId7"/>
            <a:srcRect l="75605" t="45280" r="13506" b="48710"/>
            <a:stretch/>
          </p:blipFill>
          <p:spPr>
            <a:xfrm>
              <a:off x="10017838" y="6113758"/>
              <a:ext cx="656220" cy="224039"/>
            </a:xfrm>
            <a:prstGeom prst="rect">
              <a:avLst/>
            </a:prstGeom>
          </p:spPr>
        </p:pic>
        <p:pic>
          <p:nvPicPr>
            <p:cNvPr id="20" name="Imagen 19"/>
            <p:cNvPicPr>
              <a:picLocks noChangeAspect="1"/>
            </p:cNvPicPr>
            <p:nvPr/>
          </p:nvPicPr>
          <p:blipFill rotWithShape="1">
            <a:blip r:embed="rId7"/>
            <a:srcRect l="75729" t="50489" r="14569" b="43686"/>
            <a:stretch/>
          </p:blipFill>
          <p:spPr>
            <a:xfrm>
              <a:off x="10875966" y="6120620"/>
              <a:ext cx="584692" cy="217177"/>
            </a:xfrm>
            <a:prstGeom prst="rect">
              <a:avLst/>
            </a:prstGeom>
          </p:spPr>
        </p:pic>
        <p:sp>
          <p:nvSpPr>
            <p:cNvPr id="21" name="Rectángulo 20"/>
            <p:cNvSpPr/>
            <p:nvPr/>
          </p:nvSpPr>
          <p:spPr>
            <a:xfrm>
              <a:off x="9277992" y="5637643"/>
              <a:ext cx="2252354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Red blood cell count</a:t>
              </a:r>
              <a:endParaRPr lang="en-GB" sz="14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804966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CC576ECDEC992943BFF87CECBFEFDB41" ma:contentTypeVersion="17" ma:contentTypeDescription="Crear nuevo documento." ma:contentTypeScope="" ma:versionID="043a1a5875e90e2f106356b489ccdafa">
  <xsd:schema xmlns:xsd="http://www.w3.org/2001/XMLSchema" xmlns:xs="http://www.w3.org/2001/XMLSchema" xmlns:p="http://schemas.microsoft.com/office/2006/metadata/properties" xmlns:ns3="1e3cae97-c2e1-4f44-9969-3c063664b023" xmlns:ns4="bfb132b6-1b5b-4de5-83c7-14ddfb4dc3aa" targetNamespace="http://schemas.microsoft.com/office/2006/metadata/properties" ma:root="true" ma:fieldsID="8cc8e86f71360eff67c2b14d93b7c8be" ns3:_="" ns4:_="">
    <xsd:import namespace="1e3cae97-c2e1-4f44-9969-3c063664b023"/>
    <xsd:import namespace="bfb132b6-1b5b-4de5-83c7-14ddfb4dc3a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3cae97-c2e1-4f44-9969-3c063664b02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fb132b6-1b5b-4de5-83c7-14ddfb4dc3aa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3cae97-c2e1-4f44-9969-3c063664b023" xsi:nil="true"/>
  </documentManagement>
</p:properties>
</file>

<file path=customXml/itemProps1.xml><?xml version="1.0" encoding="utf-8"?>
<ds:datastoreItem xmlns:ds="http://schemas.openxmlformats.org/officeDocument/2006/customXml" ds:itemID="{636DC9A1-6DA5-4F02-A62C-8D203FFE05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3cae97-c2e1-4f44-9969-3c063664b023"/>
    <ds:schemaRef ds:uri="bfb132b6-1b5b-4de5-83c7-14ddfb4dc3a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7AA19B1-DCC2-4F78-8856-8739CF80C05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5B8D9CF-F7B4-4160-A0AB-BFB24B0F3A6B}">
  <ds:schemaRefs>
    <ds:schemaRef ds:uri="http://purl.org/dc/terms/"/>
    <ds:schemaRef ds:uri="http://schemas.openxmlformats.org/package/2006/metadata/core-properties"/>
    <ds:schemaRef ds:uri="http://purl.org/dc/dcmitype/"/>
    <ds:schemaRef ds:uri="bfb132b6-1b5b-4de5-83c7-14ddfb4dc3aa"/>
    <ds:schemaRef ds:uri="http://schemas.microsoft.com/office/2006/documentManagement/types"/>
    <ds:schemaRef ds:uri="http://purl.org/dc/elements/1.1/"/>
    <ds:schemaRef ds:uri="http://schemas.microsoft.com/office/2006/metadata/properties"/>
    <ds:schemaRef ds:uri="1e3cae97-c2e1-4f44-9969-3c063664b023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602</TotalTime>
  <Words>790</Words>
  <Application>Microsoft Office PowerPoint</Application>
  <PresentationFormat>Personalizado</PresentationFormat>
  <Paragraphs>61</Paragraphs>
  <Slides>13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Helvetica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gargon1@gmail.com</dc:creator>
  <cp:lastModifiedBy>pablogargon1@gmail.com</cp:lastModifiedBy>
  <cp:revision>1267</cp:revision>
  <dcterms:created xsi:type="dcterms:W3CDTF">2024-07-08T10:15:09Z</dcterms:created>
  <dcterms:modified xsi:type="dcterms:W3CDTF">2026-02-02T14:47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C576ECDEC992943BFF87CECBFEFDB41</vt:lpwstr>
  </property>
</Properties>
</file>